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642CA-5E20-4801-9600-55B8409157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002A1-9014-4ECF-A3C1-2470FCE4D4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F9820-45A3-4E3D-8474-84211FA1A8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E8BCB-0CA1-4579-B71B-93435330FA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3DF00-C489-4896-A182-0ED79E32F8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9363D-DA3B-4BD2-BA70-0BE0649D33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13DD4-1A00-46A4-991F-007E61D20B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54754-E564-473A-B841-8D1145C736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9FD0F-2EBC-466E-A242-1A05BEC248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50CBD-0145-4B13-BA79-F45F62AA47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5F965-A07C-4187-AF31-9140B46317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39142-0D39-4E76-A0E2-3395E5E533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FFEBCC-7A46-48BE-A787-DBB7F77E264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9"/>
          <p:cNvSpPr/>
          <p:nvPr/>
        </p:nvSpPr>
        <p:spPr>
          <a:xfrm>
            <a:off x="142920" y="8224920"/>
            <a:ext cx="65260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4. Transcript dynamics of the genes related to CCM and photorespiration metabolism in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N. oceanica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IMET1 as measured by mRNA-Seq and real-time quantitative PCR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Each data point represents the average of three biological replicates. Each sample is analyzed in technical triplicat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tretch/>
        </p:blipFill>
        <p:spPr>
          <a:xfrm>
            <a:off x="144360" y="496800"/>
            <a:ext cx="6570720" cy="7667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6T02:16:16Z</dcterms:created>
  <dc:creator>weili</dc:creator>
  <dc:description/>
  <dc:language>en-US</dc:language>
  <cp:lastModifiedBy>Srividya S</cp:lastModifiedBy>
  <dcterms:modified xsi:type="dcterms:W3CDTF">2019-06-19T13:45:02Z</dcterms:modified>
  <cp:revision>535</cp:revision>
  <dc:subject/>
  <dc:title>Main figure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84</vt:lpwstr>
  </property>
</Properties>
</file>